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游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60520" y="1142640"/>
            <a:ext cx="213696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游ゴシック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游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4CC567-11D6-4B68-94DD-B28D0123AF3F}" type="slidenum">
              <a:rPr b="0" lang="ja-JP" sz="1200" spc="-1" strike="noStrike">
                <a:solidFill>
                  <a:srgbClr val="000000"/>
                </a:solidFill>
                <a:latin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360520" y="1143000"/>
            <a:ext cx="2136960" cy="308628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游ゴシック"/>
            </a:endParaRPr>
          </a:p>
        </p:txBody>
      </p:sp>
      <p:sp>
        <p:nvSpPr>
          <p:cNvPr id="70" name="スライド番号プレースホルダー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5588A1-B544-48F9-AEC4-8255DA9B206B}" type="slidenum">
              <a:rPr b="0" lang="ja-JP" sz="1200" spc="-1" strike="noStrike">
                <a:solidFill>
                  <a:srgbClr val="000000"/>
                </a:solidFill>
                <a:latin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3EF18-D4E2-4AE0-A006-A92CF4F4E1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23D1A-A5EC-4963-A78F-5019661C99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EA83F6-E94C-4AF3-9CC5-98AB4523CF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C0F4E-EFDE-4DE0-ACCE-3D0D36271F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67AFA-DED8-4F75-A51E-F9059A1B63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93CCD2-BF34-4B5F-BC27-40D8554CA3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749C6-F6CF-4ED2-89EC-8A8355ABFC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01735-8A52-42B4-821B-B355B16514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F0748-33F5-4643-94EB-4E536067B5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10D7B-13E0-4C49-8298-EE3A5DE1C3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387C4-2FD0-4B0E-8144-EF93A01DFC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2C7DA-066C-4087-ABAB-5AE52AADCC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BD0637-B08E-4378-BF30-873BDA5B4A48}" type="slidenum">
              <a:rPr b="0" lang="ja-JP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5"/>
          <p:cNvSpPr/>
          <p:nvPr/>
        </p:nvSpPr>
        <p:spPr>
          <a:xfrm>
            <a:off x="1039680" y="387360"/>
            <a:ext cx="2327400" cy="641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rticles found with the term “pituitary adenoma, FSH” published after 2000 (n = 42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8"/>
          <p:cNvSpPr/>
          <p:nvPr/>
        </p:nvSpPr>
        <p:spPr>
          <a:xfrm>
            <a:off x="1039680" y="1544760"/>
            <a:ext cx="2327400" cy="27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creened with the tit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9"/>
          <p:cNvSpPr/>
          <p:nvPr/>
        </p:nvSpPr>
        <p:spPr>
          <a:xfrm>
            <a:off x="1039680" y="2581200"/>
            <a:ext cx="2327400" cy="45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creened with the abstrac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 = 53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10"/>
          <p:cNvSpPr/>
          <p:nvPr/>
        </p:nvSpPr>
        <p:spPr>
          <a:xfrm>
            <a:off x="3971880" y="3075120"/>
            <a:ext cx="2806920" cy="15541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cluded (n = 23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rrelevant articles (n = 5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rticles not in English (n = 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bstracts were not availabl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in PubMed (n = 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e reports on male patient (n =1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se reports on postmenopausal women (n = 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11"/>
          <p:cNvSpPr/>
          <p:nvPr/>
        </p:nvSpPr>
        <p:spPr>
          <a:xfrm>
            <a:off x="1039680" y="3801960"/>
            <a:ext cx="2327400" cy="824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rticles about Functional gonadotroph pituitary adenoma in premenopausal wom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n = 30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16"/>
          <p:cNvSpPr/>
          <p:nvPr/>
        </p:nvSpPr>
        <p:spPr>
          <a:xfrm>
            <a:off x="833400" y="5452920"/>
            <a:ext cx="2778120" cy="7099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6 Case reports describe 32 cases of functional FSH secreting pituitary adenoma in premenopausal wom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直線矢印コネクタ 18"/>
          <p:cNvCxnSpPr/>
          <p:nvPr/>
        </p:nvCxnSpPr>
        <p:spPr>
          <a:xfrm>
            <a:off x="2074680" y="1115640"/>
            <a:ext cx="1080" cy="3387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5" name="直線矢印コネクタ 21"/>
          <p:cNvCxnSpPr/>
          <p:nvPr/>
        </p:nvCxnSpPr>
        <p:spPr>
          <a:xfrm>
            <a:off x="2074680" y="2093760"/>
            <a:ext cx="1080" cy="4104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直線矢印コネクタ 22"/>
          <p:cNvCxnSpPr/>
          <p:nvPr/>
        </p:nvCxnSpPr>
        <p:spPr>
          <a:xfrm>
            <a:off x="2074680" y="3298320"/>
            <a:ext cx="1080" cy="4122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直線矢印コネクタ 23"/>
          <p:cNvCxnSpPr/>
          <p:nvPr/>
        </p:nvCxnSpPr>
        <p:spPr>
          <a:xfrm>
            <a:off x="2088720" y="4881600"/>
            <a:ext cx="1080" cy="41184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8" name="直線矢印コネクタ 25"/>
          <p:cNvCxnSpPr/>
          <p:nvPr/>
        </p:nvCxnSpPr>
        <p:spPr>
          <a:xfrm>
            <a:off x="2831760" y="2292120"/>
            <a:ext cx="9262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9" name="テキスト ボックス 20"/>
          <p:cNvSpPr/>
          <p:nvPr/>
        </p:nvSpPr>
        <p:spPr>
          <a:xfrm>
            <a:off x="4421160" y="2119320"/>
            <a:ext cx="2089080" cy="27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Excluded (n = 369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0" name="直線矢印コネクタ 34"/>
          <p:cNvCxnSpPr/>
          <p:nvPr/>
        </p:nvCxnSpPr>
        <p:spPr>
          <a:xfrm>
            <a:off x="2831760" y="3444480"/>
            <a:ext cx="9262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1" name="大かっこ 35"/>
          <p:cNvSpPr/>
          <p:nvPr/>
        </p:nvSpPr>
        <p:spPr>
          <a:xfrm>
            <a:off x="4052880" y="3333600"/>
            <a:ext cx="2655720" cy="1184400"/>
          </a:xfrm>
          <a:prstGeom prst="bracketPair">
            <a:avLst>
              <a:gd name="adj" fmla="val 17129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直線矢印コネクタ 36"/>
          <p:cNvCxnSpPr/>
          <p:nvPr/>
        </p:nvCxnSpPr>
        <p:spPr>
          <a:xfrm>
            <a:off x="2841120" y="5121000"/>
            <a:ext cx="9262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3" name="テキスト ボックス 37"/>
          <p:cNvSpPr/>
          <p:nvPr/>
        </p:nvSpPr>
        <p:spPr>
          <a:xfrm>
            <a:off x="4421160" y="4932360"/>
            <a:ext cx="2089080" cy="8240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eview articles (n = 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H secreting tumor (n = 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on-functional gonadotroph adenoma (n = 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直線矢印コネクタ 39"/>
          <p:cNvCxnSpPr/>
          <p:nvPr/>
        </p:nvCxnSpPr>
        <p:spPr>
          <a:xfrm>
            <a:off x="2088720" y="6347880"/>
            <a:ext cx="1080" cy="4122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5" name="直線矢印コネクタ 40"/>
          <p:cNvCxnSpPr/>
          <p:nvPr/>
        </p:nvCxnSpPr>
        <p:spPr>
          <a:xfrm>
            <a:off x="2841120" y="6622560"/>
            <a:ext cx="9262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6" name="テキスト ボックス 42"/>
          <p:cNvSpPr/>
          <p:nvPr/>
        </p:nvSpPr>
        <p:spPr>
          <a:xfrm>
            <a:off x="4421160" y="6481800"/>
            <a:ext cx="2089080" cy="276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uplicate case (n =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テキスト ボックス 43"/>
          <p:cNvSpPr/>
          <p:nvPr/>
        </p:nvSpPr>
        <p:spPr>
          <a:xfrm>
            <a:off x="833400" y="7050240"/>
            <a:ext cx="2778120" cy="709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1 cases of functional FSH secreting pituitary adenoma in premenopausal wome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21T05:52:49Z</dcterms:created>
  <dc:creator>Microsoft Office ユーザー</dc:creator>
  <dc:description/>
  <dc:language>en-US</dc:language>
  <cp:lastModifiedBy>稲山 嘉英</cp:lastModifiedBy>
  <dcterms:modified xsi:type="dcterms:W3CDTF">2019-10-17T12:19:16Z</dcterms:modified>
  <cp:revision>131</cp:revision>
  <dc:subject/>
  <dc:title>PowerPoint プレゼンテーション</dc:title>
</cp:coreProperties>
</file>